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1" r:id="rId3"/>
    <p:sldId id="263" r:id="rId4"/>
    <p:sldId id="264" r:id="rId5"/>
    <p:sldId id="265" r:id="rId6"/>
    <p:sldId id="266" r:id="rId7"/>
    <p:sldId id="267" r:id="rId8"/>
  </p:sldIdLst>
  <p:sldSz cx="8567738" cy="6300788"/>
  <p:notesSz cx="6858000" cy="9144000"/>
  <p:defaultTextStyle>
    <a:defPPr>
      <a:defRPr lang="zh-CN"/>
    </a:defPPr>
    <a:lvl1pPr marL="0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1pPr>
    <a:lvl2pPr marL="356845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2pPr>
    <a:lvl3pPr marL="713689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3pPr>
    <a:lvl4pPr marL="1070534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4pPr>
    <a:lvl5pPr marL="1427378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5pPr>
    <a:lvl6pPr marL="1784223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6pPr>
    <a:lvl7pPr marL="2141068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7pPr>
    <a:lvl8pPr marL="2497912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8pPr>
    <a:lvl9pPr marL="2854757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85" userDrawn="1">
          <p15:clr>
            <a:srgbClr val="A4A3A4"/>
          </p15:clr>
        </p15:guide>
        <p15:guide id="2" pos="269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92" d="100"/>
          <a:sy n="92" d="100"/>
        </p:scale>
        <p:origin x="942" y="96"/>
      </p:cViewPr>
      <p:guideLst>
        <p:guide orient="horz" pos="1985"/>
        <p:guide pos="269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2581" y="1031171"/>
            <a:ext cx="7282577" cy="2193608"/>
          </a:xfrm>
        </p:spPr>
        <p:txBody>
          <a:bodyPr anchor="b"/>
          <a:lstStyle>
            <a:lvl1pPr algn="ctr">
              <a:defRPr sz="551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0967" y="3309373"/>
            <a:ext cx="6425804" cy="1521231"/>
          </a:xfrm>
        </p:spPr>
        <p:txBody>
          <a:bodyPr/>
          <a:lstStyle>
            <a:lvl1pPr marL="0" indent="0" algn="ctr">
              <a:buNone/>
              <a:defRPr sz="2205"/>
            </a:lvl1pPr>
            <a:lvl2pPr marL="420075" indent="0" algn="ctr">
              <a:buNone/>
              <a:defRPr sz="1838"/>
            </a:lvl2pPr>
            <a:lvl3pPr marL="840151" indent="0" algn="ctr">
              <a:buNone/>
              <a:defRPr sz="1654"/>
            </a:lvl3pPr>
            <a:lvl4pPr marL="1260226" indent="0" algn="ctr">
              <a:buNone/>
              <a:defRPr sz="1470"/>
            </a:lvl4pPr>
            <a:lvl5pPr marL="1680301" indent="0" algn="ctr">
              <a:buNone/>
              <a:defRPr sz="1470"/>
            </a:lvl5pPr>
            <a:lvl6pPr marL="2100377" indent="0" algn="ctr">
              <a:buNone/>
              <a:defRPr sz="1470"/>
            </a:lvl6pPr>
            <a:lvl7pPr marL="2520452" indent="0" algn="ctr">
              <a:buNone/>
              <a:defRPr sz="1470"/>
            </a:lvl7pPr>
            <a:lvl8pPr marL="2940528" indent="0" algn="ctr">
              <a:buNone/>
              <a:defRPr sz="1470"/>
            </a:lvl8pPr>
            <a:lvl9pPr marL="3360603" indent="0" algn="ctr">
              <a:buNone/>
              <a:defRPr sz="147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0074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8477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31288" y="335458"/>
            <a:ext cx="1847419" cy="533962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89032" y="335458"/>
            <a:ext cx="5435159" cy="533962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8433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102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4570" y="1570823"/>
            <a:ext cx="7389674" cy="2620952"/>
          </a:xfrm>
        </p:spPr>
        <p:txBody>
          <a:bodyPr anchor="b"/>
          <a:lstStyle>
            <a:lvl1pPr>
              <a:defRPr sz="551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4570" y="4216571"/>
            <a:ext cx="7389674" cy="1378297"/>
          </a:xfrm>
        </p:spPr>
        <p:txBody>
          <a:bodyPr/>
          <a:lstStyle>
            <a:lvl1pPr marL="0" indent="0">
              <a:buNone/>
              <a:defRPr sz="2205">
                <a:solidFill>
                  <a:schemeClr val="tx1"/>
                </a:solidFill>
              </a:defRPr>
            </a:lvl1pPr>
            <a:lvl2pPr marL="420075" indent="0">
              <a:buNone/>
              <a:defRPr sz="1838">
                <a:solidFill>
                  <a:schemeClr val="tx1">
                    <a:tint val="75000"/>
                  </a:schemeClr>
                </a:solidFill>
              </a:defRPr>
            </a:lvl2pPr>
            <a:lvl3pPr marL="840151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3pPr>
            <a:lvl4pPr marL="1260226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4pPr>
            <a:lvl5pPr marL="1680301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5pPr>
            <a:lvl6pPr marL="2100377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6pPr>
            <a:lvl7pPr marL="2520452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7pPr>
            <a:lvl8pPr marL="2940528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8pPr>
            <a:lvl9pPr marL="3360603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8890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89032" y="1677293"/>
            <a:ext cx="3641289" cy="399779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37417" y="1677293"/>
            <a:ext cx="3641289" cy="399779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012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0148" y="335460"/>
            <a:ext cx="7389674" cy="1217861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0149" y="1544569"/>
            <a:ext cx="3624554" cy="756969"/>
          </a:xfrm>
        </p:spPr>
        <p:txBody>
          <a:bodyPr anchor="b"/>
          <a:lstStyle>
            <a:lvl1pPr marL="0" indent="0">
              <a:buNone/>
              <a:defRPr sz="2205" b="1"/>
            </a:lvl1pPr>
            <a:lvl2pPr marL="420075" indent="0">
              <a:buNone/>
              <a:defRPr sz="1838" b="1"/>
            </a:lvl2pPr>
            <a:lvl3pPr marL="840151" indent="0">
              <a:buNone/>
              <a:defRPr sz="1654" b="1"/>
            </a:lvl3pPr>
            <a:lvl4pPr marL="1260226" indent="0">
              <a:buNone/>
              <a:defRPr sz="1470" b="1"/>
            </a:lvl4pPr>
            <a:lvl5pPr marL="1680301" indent="0">
              <a:buNone/>
              <a:defRPr sz="1470" b="1"/>
            </a:lvl5pPr>
            <a:lvl6pPr marL="2100377" indent="0">
              <a:buNone/>
              <a:defRPr sz="1470" b="1"/>
            </a:lvl6pPr>
            <a:lvl7pPr marL="2520452" indent="0">
              <a:buNone/>
              <a:defRPr sz="1470" b="1"/>
            </a:lvl7pPr>
            <a:lvl8pPr marL="2940528" indent="0">
              <a:buNone/>
              <a:defRPr sz="1470" b="1"/>
            </a:lvl8pPr>
            <a:lvl9pPr marL="3360603" indent="0">
              <a:buNone/>
              <a:defRPr sz="147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0149" y="2301538"/>
            <a:ext cx="3624554" cy="338521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37418" y="1544569"/>
            <a:ext cx="3642405" cy="756969"/>
          </a:xfrm>
        </p:spPr>
        <p:txBody>
          <a:bodyPr anchor="b"/>
          <a:lstStyle>
            <a:lvl1pPr marL="0" indent="0">
              <a:buNone/>
              <a:defRPr sz="2205" b="1"/>
            </a:lvl1pPr>
            <a:lvl2pPr marL="420075" indent="0">
              <a:buNone/>
              <a:defRPr sz="1838" b="1"/>
            </a:lvl2pPr>
            <a:lvl3pPr marL="840151" indent="0">
              <a:buNone/>
              <a:defRPr sz="1654" b="1"/>
            </a:lvl3pPr>
            <a:lvl4pPr marL="1260226" indent="0">
              <a:buNone/>
              <a:defRPr sz="1470" b="1"/>
            </a:lvl4pPr>
            <a:lvl5pPr marL="1680301" indent="0">
              <a:buNone/>
              <a:defRPr sz="1470" b="1"/>
            </a:lvl5pPr>
            <a:lvl6pPr marL="2100377" indent="0">
              <a:buNone/>
              <a:defRPr sz="1470" b="1"/>
            </a:lvl6pPr>
            <a:lvl7pPr marL="2520452" indent="0">
              <a:buNone/>
              <a:defRPr sz="1470" b="1"/>
            </a:lvl7pPr>
            <a:lvl8pPr marL="2940528" indent="0">
              <a:buNone/>
              <a:defRPr sz="1470" b="1"/>
            </a:lvl8pPr>
            <a:lvl9pPr marL="3360603" indent="0">
              <a:buNone/>
              <a:defRPr sz="147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37418" y="2301538"/>
            <a:ext cx="3642405" cy="338521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7218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743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7385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0148" y="420052"/>
            <a:ext cx="2763319" cy="1470184"/>
          </a:xfrm>
        </p:spPr>
        <p:txBody>
          <a:bodyPr anchor="b"/>
          <a:lstStyle>
            <a:lvl1pPr>
              <a:defRPr sz="294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42405" y="907198"/>
            <a:ext cx="4337417" cy="4477643"/>
          </a:xfrm>
        </p:spPr>
        <p:txBody>
          <a:bodyPr/>
          <a:lstStyle>
            <a:lvl1pPr>
              <a:defRPr sz="2940"/>
            </a:lvl1pPr>
            <a:lvl2pPr>
              <a:defRPr sz="2573"/>
            </a:lvl2pPr>
            <a:lvl3pPr>
              <a:defRPr sz="2205"/>
            </a:lvl3pPr>
            <a:lvl4pPr>
              <a:defRPr sz="1838"/>
            </a:lvl4pPr>
            <a:lvl5pPr>
              <a:defRPr sz="1838"/>
            </a:lvl5pPr>
            <a:lvl6pPr>
              <a:defRPr sz="1838"/>
            </a:lvl6pPr>
            <a:lvl7pPr>
              <a:defRPr sz="1838"/>
            </a:lvl7pPr>
            <a:lvl8pPr>
              <a:defRPr sz="1838"/>
            </a:lvl8pPr>
            <a:lvl9pPr>
              <a:defRPr sz="1838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0148" y="1890236"/>
            <a:ext cx="2763319" cy="3501897"/>
          </a:xfrm>
        </p:spPr>
        <p:txBody>
          <a:bodyPr/>
          <a:lstStyle>
            <a:lvl1pPr marL="0" indent="0">
              <a:buNone/>
              <a:defRPr sz="1470"/>
            </a:lvl1pPr>
            <a:lvl2pPr marL="420075" indent="0">
              <a:buNone/>
              <a:defRPr sz="1286"/>
            </a:lvl2pPr>
            <a:lvl3pPr marL="840151" indent="0">
              <a:buNone/>
              <a:defRPr sz="1103"/>
            </a:lvl3pPr>
            <a:lvl4pPr marL="1260226" indent="0">
              <a:buNone/>
              <a:defRPr sz="919"/>
            </a:lvl4pPr>
            <a:lvl5pPr marL="1680301" indent="0">
              <a:buNone/>
              <a:defRPr sz="919"/>
            </a:lvl5pPr>
            <a:lvl6pPr marL="2100377" indent="0">
              <a:buNone/>
              <a:defRPr sz="919"/>
            </a:lvl6pPr>
            <a:lvl7pPr marL="2520452" indent="0">
              <a:buNone/>
              <a:defRPr sz="919"/>
            </a:lvl7pPr>
            <a:lvl8pPr marL="2940528" indent="0">
              <a:buNone/>
              <a:defRPr sz="919"/>
            </a:lvl8pPr>
            <a:lvl9pPr marL="3360603" indent="0">
              <a:buNone/>
              <a:defRPr sz="919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0201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0148" y="420052"/>
            <a:ext cx="2763319" cy="1470184"/>
          </a:xfrm>
        </p:spPr>
        <p:txBody>
          <a:bodyPr anchor="b"/>
          <a:lstStyle>
            <a:lvl1pPr>
              <a:defRPr sz="294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42405" y="907198"/>
            <a:ext cx="4337417" cy="4477643"/>
          </a:xfrm>
        </p:spPr>
        <p:txBody>
          <a:bodyPr anchor="t"/>
          <a:lstStyle>
            <a:lvl1pPr marL="0" indent="0">
              <a:buNone/>
              <a:defRPr sz="2940"/>
            </a:lvl1pPr>
            <a:lvl2pPr marL="420075" indent="0">
              <a:buNone/>
              <a:defRPr sz="2573"/>
            </a:lvl2pPr>
            <a:lvl3pPr marL="840151" indent="0">
              <a:buNone/>
              <a:defRPr sz="2205"/>
            </a:lvl3pPr>
            <a:lvl4pPr marL="1260226" indent="0">
              <a:buNone/>
              <a:defRPr sz="1838"/>
            </a:lvl4pPr>
            <a:lvl5pPr marL="1680301" indent="0">
              <a:buNone/>
              <a:defRPr sz="1838"/>
            </a:lvl5pPr>
            <a:lvl6pPr marL="2100377" indent="0">
              <a:buNone/>
              <a:defRPr sz="1838"/>
            </a:lvl6pPr>
            <a:lvl7pPr marL="2520452" indent="0">
              <a:buNone/>
              <a:defRPr sz="1838"/>
            </a:lvl7pPr>
            <a:lvl8pPr marL="2940528" indent="0">
              <a:buNone/>
              <a:defRPr sz="1838"/>
            </a:lvl8pPr>
            <a:lvl9pPr marL="3360603" indent="0">
              <a:buNone/>
              <a:defRPr sz="1838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0148" y="1890236"/>
            <a:ext cx="2763319" cy="3501897"/>
          </a:xfrm>
        </p:spPr>
        <p:txBody>
          <a:bodyPr/>
          <a:lstStyle>
            <a:lvl1pPr marL="0" indent="0">
              <a:buNone/>
              <a:defRPr sz="1470"/>
            </a:lvl1pPr>
            <a:lvl2pPr marL="420075" indent="0">
              <a:buNone/>
              <a:defRPr sz="1286"/>
            </a:lvl2pPr>
            <a:lvl3pPr marL="840151" indent="0">
              <a:buNone/>
              <a:defRPr sz="1103"/>
            </a:lvl3pPr>
            <a:lvl4pPr marL="1260226" indent="0">
              <a:buNone/>
              <a:defRPr sz="919"/>
            </a:lvl4pPr>
            <a:lvl5pPr marL="1680301" indent="0">
              <a:buNone/>
              <a:defRPr sz="919"/>
            </a:lvl5pPr>
            <a:lvl6pPr marL="2100377" indent="0">
              <a:buNone/>
              <a:defRPr sz="919"/>
            </a:lvl6pPr>
            <a:lvl7pPr marL="2520452" indent="0">
              <a:buNone/>
              <a:defRPr sz="919"/>
            </a:lvl7pPr>
            <a:lvl8pPr marL="2940528" indent="0">
              <a:buNone/>
              <a:defRPr sz="919"/>
            </a:lvl8pPr>
            <a:lvl9pPr marL="3360603" indent="0">
              <a:buNone/>
              <a:defRPr sz="919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1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89032" y="335460"/>
            <a:ext cx="7389674" cy="1217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032" y="1677293"/>
            <a:ext cx="7389674" cy="39977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89032" y="5839898"/>
            <a:ext cx="1927741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75E90A-4DB7-4B92-A9C9-3E857C99B222}" type="datetimeFigureOut">
              <a:rPr lang="zh-CN" altLang="en-US" smtClean="0"/>
              <a:t>2017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38063" y="5839898"/>
            <a:ext cx="2891612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050965" y="5839898"/>
            <a:ext cx="1927741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3B4E2-CED0-4701-9B3A-FBF8D1A495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9253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40151" rtl="0" eaLnBrk="1" latinLnBrk="0" hangingPunct="1">
        <a:lnSpc>
          <a:spcPct val="90000"/>
        </a:lnSpc>
        <a:spcBef>
          <a:spcPct val="0"/>
        </a:spcBef>
        <a:buNone/>
        <a:defRPr sz="404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0038" indent="-210038" algn="l" defTabSz="840151" rtl="0" eaLnBrk="1" latinLnBrk="0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2573" kern="1200">
          <a:solidFill>
            <a:schemeClr val="tx1"/>
          </a:solidFill>
          <a:latin typeface="+mn-lt"/>
          <a:ea typeface="+mn-ea"/>
          <a:cs typeface="+mn-cs"/>
        </a:defRPr>
      </a:lvl1pPr>
      <a:lvl2pPr marL="630113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2pPr>
      <a:lvl3pPr marL="1050188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838" kern="1200">
          <a:solidFill>
            <a:schemeClr val="tx1"/>
          </a:solidFill>
          <a:latin typeface="+mn-lt"/>
          <a:ea typeface="+mn-ea"/>
          <a:cs typeface="+mn-cs"/>
        </a:defRPr>
      </a:lvl3pPr>
      <a:lvl4pPr marL="1470264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4pPr>
      <a:lvl5pPr marL="1890339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5pPr>
      <a:lvl6pPr marL="2310414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6pPr>
      <a:lvl7pPr marL="2730490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7pPr>
      <a:lvl8pPr marL="3150565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8pPr>
      <a:lvl9pPr marL="3570641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20075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840151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260226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4pPr>
      <a:lvl5pPr marL="1680301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5pPr>
      <a:lvl6pPr marL="2100377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6pPr>
      <a:lvl7pPr marL="2520452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7pPr>
      <a:lvl8pPr marL="2940528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8pPr>
      <a:lvl9pPr marL="3360603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9002" y="147423"/>
            <a:ext cx="6115398" cy="5826936"/>
          </a:xfrm>
        </p:spPr>
      </p:pic>
      <p:sp>
        <p:nvSpPr>
          <p:cNvPr id="7" name="文本框 6"/>
          <p:cNvSpPr txBox="1"/>
          <p:nvPr/>
        </p:nvSpPr>
        <p:spPr>
          <a:xfrm>
            <a:off x="4385554" y="4907"/>
            <a:ext cx="6130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1B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4563679" y="164662"/>
            <a:ext cx="14599" cy="14901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4597896" y="128947"/>
            <a:ext cx="7273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1D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H="1">
            <a:off x="4786096" y="184905"/>
            <a:ext cx="93518" cy="17479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4911814" y="-4610"/>
            <a:ext cx="587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1E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3" name="直接连接符 22"/>
          <p:cNvCxnSpPr/>
          <p:nvPr/>
        </p:nvCxnSpPr>
        <p:spPr>
          <a:xfrm flipH="1">
            <a:off x="5014743" y="186698"/>
            <a:ext cx="63327" cy="19155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5284931" y="43292"/>
            <a:ext cx="5714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1F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6" name="直接连接符 25"/>
          <p:cNvCxnSpPr/>
          <p:nvPr/>
        </p:nvCxnSpPr>
        <p:spPr>
          <a:xfrm flipH="1">
            <a:off x="5217327" y="157909"/>
            <a:ext cx="161053" cy="31721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5325866" y="184905"/>
            <a:ext cx="6130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1A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34" name="直接连接符 33"/>
          <p:cNvCxnSpPr/>
          <p:nvPr/>
        </p:nvCxnSpPr>
        <p:spPr>
          <a:xfrm flipH="1">
            <a:off x="5484385" y="359703"/>
            <a:ext cx="90409" cy="19633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5951985" y="73953"/>
            <a:ext cx="602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5A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38" name="直接连接符 37"/>
          <p:cNvCxnSpPr/>
          <p:nvPr/>
        </p:nvCxnSpPr>
        <p:spPr>
          <a:xfrm flipH="1">
            <a:off x="5774343" y="258980"/>
            <a:ext cx="331455" cy="23854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>
            <a:off x="6395755" y="325202"/>
            <a:ext cx="5590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7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44" name="直接连接符 43"/>
          <p:cNvCxnSpPr/>
          <p:nvPr/>
        </p:nvCxnSpPr>
        <p:spPr>
          <a:xfrm flipH="1">
            <a:off x="6033007" y="517943"/>
            <a:ext cx="521651" cy="29449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6455180" y="570101"/>
            <a:ext cx="531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48" name="直接连接符 47"/>
          <p:cNvCxnSpPr/>
          <p:nvPr/>
        </p:nvCxnSpPr>
        <p:spPr>
          <a:xfrm flipH="1">
            <a:off x="6033007" y="769192"/>
            <a:ext cx="521650" cy="25106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/>
          <p:cNvSpPr txBox="1"/>
          <p:nvPr/>
        </p:nvSpPr>
        <p:spPr>
          <a:xfrm>
            <a:off x="6951174" y="549775"/>
            <a:ext cx="5091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RH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53" name="直接连接符 52"/>
          <p:cNvCxnSpPr/>
          <p:nvPr/>
        </p:nvCxnSpPr>
        <p:spPr>
          <a:xfrm flipV="1">
            <a:off x="6301132" y="733816"/>
            <a:ext cx="685971" cy="37996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>
            <a:off x="6904416" y="861047"/>
            <a:ext cx="602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RB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58" name="直接连接符 57"/>
          <p:cNvCxnSpPr/>
          <p:nvPr/>
        </p:nvCxnSpPr>
        <p:spPr>
          <a:xfrm flipH="1">
            <a:off x="6469544" y="1016546"/>
            <a:ext cx="517559" cy="24789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本框 59"/>
          <p:cNvSpPr txBox="1"/>
          <p:nvPr/>
        </p:nvSpPr>
        <p:spPr>
          <a:xfrm>
            <a:off x="7261178" y="1049931"/>
            <a:ext cx="571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RB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62" name="直接连接符 61"/>
          <p:cNvCxnSpPr/>
          <p:nvPr/>
        </p:nvCxnSpPr>
        <p:spPr>
          <a:xfrm flipH="1">
            <a:off x="6668257" y="1205062"/>
            <a:ext cx="600857" cy="2178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>
            <a:off x="7483559" y="1269451"/>
            <a:ext cx="6040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RB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65" name="直接连接符 64"/>
          <p:cNvCxnSpPr/>
          <p:nvPr/>
        </p:nvCxnSpPr>
        <p:spPr>
          <a:xfrm flipV="1">
            <a:off x="6812659" y="1438494"/>
            <a:ext cx="707296" cy="22043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/>
        </p:nvSpPr>
        <p:spPr>
          <a:xfrm>
            <a:off x="7703803" y="1695108"/>
            <a:ext cx="4883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6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68" name="直接连接符 67"/>
          <p:cNvCxnSpPr/>
          <p:nvPr/>
        </p:nvCxnSpPr>
        <p:spPr>
          <a:xfrm flipV="1">
            <a:off x="7101130" y="1842254"/>
            <a:ext cx="602673" cy="415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文本框 68"/>
          <p:cNvSpPr txBox="1"/>
          <p:nvPr/>
        </p:nvSpPr>
        <p:spPr>
          <a:xfrm>
            <a:off x="7546928" y="2067140"/>
            <a:ext cx="5834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DRD5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71" name="直接连接符 70"/>
          <p:cNvCxnSpPr>
            <a:endCxn id="69" idx="1"/>
          </p:cNvCxnSpPr>
          <p:nvPr/>
        </p:nvCxnSpPr>
        <p:spPr>
          <a:xfrm>
            <a:off x="7121764" y="2182556"/>
            <a:ext cx="42516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/>
          <p:cNvSpPr txBox="1"/>
          <p:nvPr/>
        </p:nvSpPr>
        <p:spPr>
          <a:xfrm>
            <a:off x="7703803" y="2323756"/>
            <a:ext cx="563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DRD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77" name="直接连接符 76"/>
          <p:cNvCxnSpPr>
            <a:endCxn id="75" idx="1"/>
          </p:cNvCxnSpPr>
          <p:nvPr/>
        </p:nvCxnSpPr>
        <p:spPr>
          <a:xfrm flipV="1">
            <a:off x="7160740" y="2439172"/>
            <a:ext cx="543062" cy="4212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77"/>
          <p:cNvSpPr txBox="1"/>
          <p:nvPr/>
        </p:nvSpPr>
        <p:spPr>
          <a:xfrm>
            <a:off x="7677624" y="2640309"/>
            <a:ext cx="5407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DRD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80" name="直接连接符 79"/>
          <p:cNvCxnSpPr>
            <a:endCxn id="78" idx="1"/>
          </p:cNvCxnSpPr>
          <p:nvPr/>
        </p:nvCxnSpPr>
        <p:spPr>
          <a:xfrm>
            <a:off x="7176049" y="2755725"/>
            <a:ext cx="50157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文本框 81"/>
          <p:cNvSpPr txBox="1"/>
          <p:nvPr/>
        </p:nvSpPr>
        <p:spPr>
          <a:xfrm>
            <a:off x="7832679" y="2871141"/>
            <a:ext cx="6388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DRD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84" name="直接连接符 83"/>
          <p:cNvCxnSpPr>
            <a:endCxn id="82" idx="1"/>
          </p:cNvCxnSpPr>
          <p:nvPr/>
        </p:nvCxnSpPr>
        <p:spPr>
          <a:xfrm>
            <a:off x="7176050" y="2984139"/>
            <a:ext cx="656629" cy="241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文本框 84"/>
          <p:cNvSpPr txBox="1"/>
          <p:nvPr/>
        </p:nvSpPr>
        <p:spPr>
          <a:xfrm>
            <a:off x="7986497" y="3223130"/>
            <a:ext cx="5611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DRD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87" name="直接连接符 86"/>
          <p:cNvCxnSpPr>
            <a:endCxn id="85" idx="1"/>
          </p:cNvCxnSpPr>
          <p:nvPr/>
        </p:nvCxnSpPr>
        <p:spPr>
          <a:xfrm>
            <a:off x="7261178" y="3264694"/>
            <a:ext cx="725318" cy="7385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文本框 87"/>
          <p:cNvSpPr txBox="1"/>
          <p:nvPr/>
        </p:nvSpPr>
        <p:spPr>
          <a:xfrm>
            <a:off x="7832679" y="3453962"/>
            <a:ext cx="7149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RA1D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90" name="直接连接符 89"/>
          <p:cNvCxnSpPr>
            <a:endCxn id="88" idx="1"/>
          </p:cNvCxnSpPr>
          <p:nvPr/>
        </p:nvCxnSpPr>
        <p:spPr>
          <a:xfrm>
            <a:off x="7261178" y="3453962"/>
            <a:ext cx="571500" cy="1154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文本框 91"/>
          <p:cNvSpPr txBox="1"/>
          <p:nvPr/>
        </p:nvSpPr>
        <p:spPr>
          <a:xfrm>
            <a:off x="7681697" y="3757853"/>
            <a:ext cx="7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RA1A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8291297" y="4151385"/>
            <a:ext cx="4850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7332423" y="4018357"/>
            <a:ext cx="7273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RA1B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96" name="直接连接符 95"/>
          <p:cNvCxnSpPr>
            <a:endCxn id="92" idx="1"/>
          </p:cNvCxnSpPr>
          <p:nvPr/>
        </p:nvCxnSpPr>
        <p:spPr>
          <a:xfrm>
            <a:off x="7156072" y="3721779"/>
            <a:ext cx="525624" cy="15149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接连接符 97"/>
          <p:cNvCxnSpPr/>
          <p:nvPr/>
        </p:nvCxnSpPr>
        <p:spPr>
          <a:xfrm>
            <a:off x="6986707" y="3953742"/>
            <a:ext cx="359199" cy="11753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文本框 100"/>
          <p:cNvSpPr txBox="1"/>
          <p:nvPr/>
        </p:nvSpPr>
        <p:spPr>
          <a:xfrm>
            <a:off x="7378861" y="4384358"/>
            <a:ext cx="6706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RA2A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03" name="直接连接符 102"/>
          <p:cNvCxnSpPr/>
          <p:nvPr/>
        </p:nvCxnSpPr>
        <p:spPr>
          <a:xfrm>
            <a:off x="6819391" y="4237479"/>
            <a:ext cx="579143" cy="22026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文本框 103"/>
          <p:cNvSpPr txBox="1"/>
          <p:nvPr/>
        </p:nvSpPr>
        <p:spPr>
          <a:xfrm>
            <a:off x="7507088" y="4688249"/>
            <a:ext cx="6850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RA2C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06" name="直接连接符 105"/>
          <p:cNvCxnSpPr>
            <a:endCxn id="104" idx="1"/>
          </p:cNvCxnSpPr>
          <p:nvPr/>
        </p:nvCxnSpPr>
        <p:spPr>
          <a:xfrm>
            <a:off x="6812659" y="4497633"/>
            <a:ext cx="694428" cy="30603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文本框 106"/>
          <p:cNvSpPr txBox="1"/>
          <p:nvPr/>
        </p:nvSpPr>
        <p:spPr>
          <a:xfrm>
            <a:off x="7205410" y="4881242"/>
            <a:ext cx="7173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RA2B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09" name="直接连接符 108"/>
          <p:cNvCxnSpPr/>
          <p:nvPr/>
        </p:nvCxnSpPr>
        <p:spPr>
          <a:xfrm>
            <a:off x="6668256" y="4688249"/>
            <a:ext cx="558426" cy="26558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文本框 109"/>
          <p:cNvSpPr txBox="1"/>
          <p:nvPr/>
        </p:nvSpPr>
        <p:spPr>
          <a:xfrm>
            <a:off x="6931398" y="5065343"/>
            <a:ext cx="5598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2B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12" name="直接连接符 111"/>
          <p:cNvCxnSpPr/>
          <p:nvPr/>
        </p:nvCxnSpPr>
        <p:spPr>
          <a:xfrm>
            <a:off x="6554657" y="4872153"/>
            <a:ext cx="432873" cy="22525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文本框 112"/>
          <p:cNvSpPr txBox="1"/>
          <p:nvPr/>
        </p:nvSpPr>
        <p:spPr>
          <a:xfrm>
            <a:off x="6642603" y="5269904"/>
            <a:ext cx="5957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2A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15" name="直接连接符 114"/>
          <p:cNvCxnSpPr/>
          <p:nvPr/>
        </p:nvCxnSpPr>
        <p:spPr>
          <a:xfrm>
            <a:off x="6383651" y="5005402"/>
            <a:ext cx="395031" cy="27731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文本框 116"/>
          <p:cNvSpPr txBox="1"/>
          <p:nvPr/>
        </p:nvSpPr>
        <p:spPr>
          <a:xfrm>
            <a:off x="6264655" y="5393371"/>
            <a:ext cx="5913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TR2B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19" name="直接连接符 118"/>
          <p:cNvCxnSpPr/>
          <p:nvPr/>
        </p:nvCxnSpPr>
        <p:spPr>
          <a:xfrm>
            <a:off x="6308884" y="5096341"/>
            <a:ext cx="183588" cy="30116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文本框 120"/>
          <p:cNvSpPr txBox="1"/>
          <p:nvPr/>
        </p:nvSpPr>
        <p:spPr>
          <a:xfrm>
            <a:off x="6330119" y="5603649"/>
            <a:ext cx="7138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ORA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23" name="直接连接符 122"/>
          <p:cNvCxnSpPr/>
          <p:nvPr/>
        </p:nvCxnSpPr>
        <p:spPr>
          <a:xfrm>
            <a:off x="6078730" y="5150374"/>
            <a:ext cx="311317" cy="5186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文本框 123"/>
          <p:cNvSpPr txBox="1"/>
          <p:nvPr/>
        </p:nvSpPr>
        <p:spPr>
          <a:xfrm>
            <a:off x="5821902" y="5739193"/>
            <a:ext cx="7060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ORA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26" name="直接连接符 125"/>
          <p:cNvCxnSpPr/>
          <p:nvPr/>
        </p:nvCxnSpPr>
        <p:spPr>
          <a:xfrm>
            <a:off x="5877404" y="5282721"/>
            <a:ext cx="155602" cy="5135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文本框 126"/>
          <p:cNvSpPr txBox="1"/>
          <p:nvPr/>
        </p:nvSpPr>
        <p:spPr>
          <a:xfrm>
            <a:off x="5633312" y="6041411"/>
            <a:ext cx="7803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ORA2A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29" name="直接连接符 128"/>
          <p:cNvCxnSpPr/>
          <p:nvPr/>
        </p:nvCxnSpPr>
        <p:spPr>
          <a:xfrm>
            <a:off x="5647141" y="5301238"/>
            <a:ext cx="257539" cy="76060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文本框 129"/>
          <p:cNvSpPr txBox="1"/>
          <p:nvPr/>
        </p:nvSpPr>
        <p:spPr>
          <a:xfrm>
            <a:off x="5299154" y="5863424"/>
            <a:ext cx="7712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DORA2B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32" name="直接连接符 131"/>
          <p:cNvCxnSpPr/>
          <p:nvPr/>
        </p:nvCxnSpPr>
        <p:spPr>
          <a:xfrm>
            <a:off x="5428862" y="5375905"/>
            <a:ext cx="135591" cy="33974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文本框 132"/>
          <p:cNvSpPr txBox="1"/>
          <p:nvPr/>
        </p:nvSpPr>
        <p:spPr>
          <a:xfrm>
            <a:off x="5136118" y="5660385"/>
            <a:ext cx="5506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MC4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35" name="直接连接符 134"/>
          <p:cNvCxnSpPr>
            <a:endCxn id="133" idx="0"/>
          </p:cNvCxnSpPr>
          <p:nvPr/>
        </p:nvCxnSpPr>
        <p:spPr>
          <a:xfrm>
            <a:off x="5353881" y="5546945"/>
            <a:ext cx="57567" cy="1134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文本框 136"/>
          <p:cNvSpPr txBox="1"/>
          <p:nvPr/>
        </p:nvSpPr>
        <p:spPr>
          <a:xfrm>
            <a:off x="4902889" y="5829182"/>
            <a:ext cx="5279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MC5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39" name="直接连接符 138"/>
          <p:cNvCxnSpPr>
            <a:endCxn id="137" idx="0"/>
          </p:cNvCxnSpPr>
          <p:nvPr/>
        </p:nvCxnSpPr>
        <p:spPr>
          <a:xfrm>
            <a:off x="5073289" y="5651691"/>
            <a:ext cx="93564" cy="17749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文本框 139"/>
          <p:cNvSpPr txBox="1"/>
          <p:nvPr/>
        </p:nvSpPr>
        <p:spPr>
          <a:xfrm>
            <a:off x="4676604" y="6051378"/>
            <a:ext cx="5466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MC3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42" name="直接连接符 141"/>
          <p:cNvCxnSpPr/>
          <p:nvPr/>
        </p:nvCxnSpPr>
        <p:spPr>
          <a:xfrm>
            <a:off x="4900781" y="5637233"/>
            <a:ext cx="13716" cy="28080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文本框 142"/>
          <p:cNvSpPr txBox="1"/>
          <p:nvPr/>
        </p:nvSpPr>
        <p:spPr>
          <a:xfrm>
            <a:off x="4455062" y="5896126"/>
            <a:ext cx="5383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MC2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45" name="直接连接符 144"/>
          <p:cNvCxnSpPr>
            <a:endCxn id="143" idx="0"/>
          </p:cNvCxnSpPr>
          <p:nvPr/>
        </p:nvCxnSpPr>
        <p:spPr>
          <a:xfrm>
            <a:off x="4685962" y="5674117"/>
            <a:ext cx="38280" cy="22200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文本框 146"/>
          <p:cNvSpPr txBox="1"/>
          <p:nvPr/>
        </p:nvSpPr>
        <p:spPr>
          <a:xfrm>
            <a:off x="4111475" y="5894197"/>
            <a:ext cx="5738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MC1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49" name="直接连接符 148"/>
          <p:cNvCxnSpPr/>
          <p:nvPr/>
        </p:nvCxnSpPr>
        <p:spPr>
          <a:xfrm>
            <a:off x="4385554" y="5708666"/>
            <a:ext cx="0" cy="22641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文本框 149"/>
          <p:cNvSpPr txBox="1"/>
          <p:nvPr/>
        </p:nvSpPr>
        <p:spPr>
          <a:xfrm>
            <a:off x="3741922" y="6033457"/>
            <a:ext cx="527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N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52" name="直接连接符 151"/>
          <p:cNvCxnSpPr/>
          <p:nvPr/>
        </p:nvCxnSpPr>
        <p:spPr>
          <a:xfrm flipH="1">
            <a:off x="3943350" y="5796282"/>
            <a:ext cx="57151" cy="25154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文本框 152"/>
          <p:cNvSpPr txBox="1"/>
          <p:nvPr/>
        </p:nvSpPr>
        <p:spPr>
          <a:xfrm>
            <a:off x="3432239" y="5911495"/>
            <a:ext cx="5101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NR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55" name="直接连接符 154"/>
          <p:cNvCxnSpPr/>
          <p:nvPr/>
        </p:nvCxnSpPr>
        <p:spPr>
          <a:xfrm flipV="1">
            <a:off x="3712994" y="5796282"/>
            <a:ext cx="47800" cy="8313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/>
          <p:cNvSpPr txBox="1"/>
          <p:nvPr/>
        </p:nvSpPr>
        <p:spPr>
          <a:xfrm>
            <a:off x="3113201" y="5979747"/>
            <a:ext cx="6345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58" name="直接连接符 157"/>
          <p:cNvCxnSpPr>
            <a:endCxn id="156" idx="0"/>
          </p:cNvCxnSpPr>
          <p:nvPr/>
        </p:nvCxnSpPr>
        <p:spPr>
          <a:xfrm flipH="1">
            <a:off x="3430497" y="5726809"/>
            <a:ext cx="186942" cy="25293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文本框 159"/>
          <p:cNvSpPr txBox="1"/>
          <p:nvPr/>
        </p:nvSpPr>
        <p:spPr>
          <a:xfrm>
            <a:off x="2822130" y="5882795"/>
            <a:ext cx="5611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1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62" name="直接连接符 161"/>
          <p:cNvCxnSpPr>
            <a:endCxn id="160" idx="0"/>
          </p:cNvCxnSpPr>
          <p:nvPr/>
        </p:nvCxnSpPr>
        <p:spPr>
          <a:xfrm flipH="1">
            <a:off x="3102729" y="5557066"/>
            <a:ext cx="192265" cy="32572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文本框 164"/>
          <p:cNvSpPr txBox="1"/>
          <p:nvPr/>
        </p:nvSpPr>
        <p:spPr>
          <a:xfrm>
            <a:off x="2598346" y="5680866"/>
            <a:ext cx="4969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6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67" name="直接连接符 166"/>
          <p:cNvCxnSpPr>
            <a:endCxn id="165" idx="0"/>
          </p:cNvCxnSpPr>
          <p:nvPr/>
        </p:nvCxnSpPr>
        <p:spPr>
          <a:xfrm flipH="1">
            <a:off x="2846820" y="5469260"/>
            <a:ext cx="228085" cy="21160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文本框 167"/>
          <p:cNvSpPr txBox="1"/>
          <p:nvPr/>
        </p:nvSpPr>
        <p:spPr>
          <a:xfrm>
            <a:off x="2328720" y="5536275"/>
            <a:ext cx="5271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RH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70" name="直接连接符 169"/>
          <p:cNvCxnSpPr/>
          <p:nvPr/>
        </p:nvCxnSpPr>
        <p:spPr>
          <a:xfrm flipH="1">
            <a:off x="2642456" y="5285133"/>
            <a:ext cx="213436" cy="2902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文本框 170"/>
          <p:cNvSpPr txBox="1"/>
          <p:nvPr/>
        </p:nvSpPr>
        <p:spPr>
          <a:xfrm>
            <a:off x="1981603" y="5298715"/>
            <a:ext cx="7315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HRM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73" name="直接连接符 172"/>
          <p:cNvCxnSpPr>
            <a:endCxn id="171" idx="0"/>
          </p:cNvCxnSpPr>
          <p:nvPr/>
        </p:nvCxnSpPr>
        <p:spPr>
          <a:xfrm flipH="1">
            <a:off x="2347388" y="5130387"/>
            <a:ext cx="155531" cy="16832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文本框 173"/>
          <p:cNvSpPr txBox="1"/>
          <p:nvPr/>
        </p:nvSpPr>
        <p:spPr>
          <a:xfrm>
            <a:off x="1606633" y="5066272"/>
            <a:ext cx="6383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HRM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76" name="直接连接符 175"/>
          <p:cNvCxnSpPr>
            <a:endCxn id="174" idx="0"/>
          </p:cNvCxnSpPr>
          <p:nvPr/>
        </p:nvCxnSpPr>
        <p:spPr>
          <a:xfrm flipH="1">
            <a:off x="1925816" y="4866796"/>
            <a:ext cx="296042" cy="19947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文本框 176"/>
          <p:cNvSpPr txBox="1"/>
          <p:nvPr/>
        </p:nvSpPr>
        <p:spPr>
          <a:xfrm>
            <a:off x="1277901" y="4820386"/>
            <a:ext cx="6365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HRM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79" name="直接连接符 178"/>
          <p:cNvCxnSpPr/>
          <p:nvPr/>
        </p:nvCxnSpPr>
        <p:spPr>
          <a:xfrm flipH="1">
            <a:off x="1809400" y="4650649"/>
            <a:ext cx="338783" cy="2107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文本框 179"/>
          <p:cNvSpPr txBox="1"/>
          <p:nvPr/>
        </p:nvSpPr>
        <p:spPr>
          <a:xfrm>
            <a:off x="1070919" y="4497633"/>
            <a:ext cx="6706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HRM5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82" name="直接连接符 181"/>
          <p:cNvCxnSpPr/>
          <p:nvPr/>
        </p:nvCxnSpPr>
        <p:spPr>
          <a:xfrm flipV="1">
            <a:off x="1544133" y="4497633"/>
            <a:ext cx="515700" cy="1154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文本框 183"/>
          <p:cNvSpPr txBox="1"/>
          <p:nvPr/>
        </p:nvSpPr>
        <p:spPr>
          <a:xfrm>
            <a:off x="835138" y="4290296"/>
            <a:ext cx="5690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50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86" name="直接连接符 185"/>
          <p:cNvCxnSpPr>
            <a:stCxn id="184" idx="3"/>
          </p:cNvCxnSpPr>
          <p:nvPr/>
        </p:nvCxnSpPr>
        <p:spPr>
          <a:xfrm flipV="1">
            <a:off x="1404203" y="4336574"/>
            <a:ext cx="429113" cy="6913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文本框 187"/>
          <p:cNvSpPr txBox="1"/>
          <p:nvPr/>
        </p:nvSpPr>
        <p:spPr>
          <a:xfrm>
            <a:off x="766321" y="4039424"/>
            <a:ext cx="7319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MTNR1B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89" name="文本框 188"/>
          <p:cNvSpPr txBox="1"/>
          <p:nvPr/>
        </p:nvSpPr>
        <p:spPr>
          <a:xfrm>
            <a:off x="746906" y="3757853"/>
            <a:ext cx="6763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MTNR1A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91" name="直接连接符 190"/>
          <p:cNvCxnSpPr>
            <a:endCxn id="189" idx="3"/>
          </p:cNvCxnSpPr>
          <p:nvPr/>
        </p:nvCxnSpPr>
        <p:spPr>
          <a:xfrm flipH="1" flipV="1">
            <a:off x="1423287" y="3873269"/>
            <a:ext cx="378697" cy="26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直接连接符 192"/>
          <p:cNvCxnSpPr/>
          <p:nvPr/>
        </p:nvCxnSpPr>
        <p:spPr>
          <a:xfrm flipH="1">
            <a:off x="1404203" y="4104102"/>
            <a:ext cx="429113" cy="3395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文本框 193"/>
          <p:cNvSpPr txBox="1"/>
          <p:nvPr/>
        </p:nvSpPr>
        <p:spPr>
          <a:xfrm>
            <a:off x="593088" y="3569378"/>
            <a:ext cx="5265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OPN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96" name="直接连接符 195"/>
          <p:cNvCxnSpPr>
            <a:stCxn id="194" idx="3"/>
          </p:cNvCxnSpPr>
          <p:nvPr/>
        </p:nvCxnSpPr>
        <p:spPr>
          <a:xfrm>
            <a:off x="1119670" y="3684794"/>
            <a:ext cx="56091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文本框 196"/>
          <p:cNvSpPr txBox="1"/>
          <p:nvPr/>
        </p:nvSpPr>
        <p:spPr>
          <a:xfrm>
            <a:off x="666696" y="3338546"/>
            <a:ext cx="4778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RRH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99" name="直接连接符 198"/>
          <p:cNvCxnSpPr/>
          <p:nvPr/>
        </p:nvCxnSpPr>
        <p:spPr>
          <a:xfrm>
            <a:off x="1119670" y="3453962"/>
            <a:ext cx="4738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文本框 199"/>
          <p:cNvSpPr txBox="1"/>
          <p:nvPr/>
        </p:nvSpPr>
        <p:spPr>
          <a:xfrm>
            <a:off x="593088" y="2902309"/>
            <a:ext cx="5637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OPN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02" name="直接连接符 201"/>
          <p:cNvCxnSpPr/>
          <p:nvPr/>
        </p:nvCxnSpPr>
        <p:spPr>
          <a:xfrm flipH="1" flipV="1">
            <a:off x="1114466" y="3025039"/>
            <a:ext cx="429668" cy="7693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文本框 202"/>
          <p:cNvSpPr txBox="1"/>
          <p:nvPr/>
        </p:nvSpPr>
        <p:spPr>
          <a:xfrm>
            <a:off x="340938" y="2586869"/>
            <a:ext cx="7568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OPN1MW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04" name="文本框 203"/>
          <p:cNvSpPr txBox="1"/>
          <p:nvPr/>
        </p:nvSpPr>
        <p:spPr>
          <a:xfrm>
            <a:off x="324282" y="2266048"/>
            <a:ext cx="7568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OPN1SW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05" name="直接连接符 204"/>
          <p:cNvCxnSpPr/>
          <p:nvPr/>
        </p:nvCxnSpPr>
        <p:spPr>
          <a:xfrm flipH="1" flipV="1">
            <a:off x="1070919" y="2733453"/>
            <a:ext cx="409699" cy="8424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直接连接符 205"/>
          <p:cNvCxnSpPr/>
          <p:nvPr/>
        </p:nvCxnSpPr>
        <p:spPr>
          <a:xfrm flipH="1" flipV="1">
            <a:off x="996051" y="2443252"/>
            <a:ext cx="544920" cy="12325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文本框 206"/>
          <p:cNvSpPr txBox="1"/>
          <p:nvPr/>
        </p:nvSpPr>
        <p:spPr>
          <a:xfrm>
            <a:off x="775326" y="1999052"/>
            <a:ext cx="4778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RHO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09" name="直接连接符 208"/>
          <p:cNvCxnSpPr/>
          <p:nvPr/>
        </p:nvCxnSpPr>
        <p:spPr>
          <a:xfrm>
            <a:off x="1226314" y="2182556"/>
            <a:ext cx="454268" cy="1154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5" name="文本框 214"/>
          <p:cNvSpPr txBox="1"/>
          <p:nvPr/>
        </p:nvSpPr>
        <p:spPr>
          <a:xfrm>
            <a:off x="1226314" y="1655038"/>
            <a:ext cx="5885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85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17" name="直接连接符 216"/>
          <p:cNvCxnSpPr/>
          <p:nvPr/>
        </p:nvCxnSpPr>
        <p:spPr>
          <a:xfrm>
            <a:off x="1680582" y="1807745"/>
            <a:ext cx="257634" cy="13433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文本框 218"/>
          <p:cNvSpPr txBox="1"/>
          <p:nvPr/>
        </p:nvSpPr>
        <p:spPr>
          <a:xfrm>
            <a:off x="1069850" y="1881826"/>
            <a:ext cx="6288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27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21" name="直接连接符 220"/>
          <p:cNvCxnSpPr/>
          <p:nvPr/>
        </p:nvCxnSpPr>
        <p:spPr>
          <a:xfrm>
            <a:off x="1529986" y="2050354"/>
            <a:ext cx="297926" cy="8219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文本框 221"/>
          <p:cNvSpPr txBox="1"/>
          <p:nvPr/>
        </p:nvSpPr>
        <p:spPr>
          <a:xfrm>
            <a:off x="1016047" y="1406124"/>
            <a:ext cx="6107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TGF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24" name="直接连接符 223"/>
          <p:cNvCxnSpPr/>
          <p:nvPr/>
        </p:nvCxnSpPr>
        <p:spPr>
          <a:xfrm>
            <a:off x="1480618" y="1537812"/>
            <a:ext cx="347295" cy="8560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文本框 225"/>
          <p:cNvSpPr txBox="1"/>
          <p:nvPr/>
        </p:nvSpPr>
        <p:spPr>
          <a:xfrm>
            <a:off x="1069850" y="1121331"/>
            <a:ext cx="7119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TGE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28" name="直接连接符 227"/>
          <p:cNvCxnSpPr/>
          <p:nvPr/>
        </p:nvCxnSpPr>
        <p:spPr>
          <a:xfrm>
            <a:off x="1612634" y="1278335"/>
            <a:ext cx="368968" cy="10438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文本框 229"/>
          <p:cNvSpPr txBox="1"/>
          <p:nvPr/>
        </p:nvSpPr>
        <p:spPr>
          <a:xfrm>
            <a:off x="1457476" y="811876"/>
            <a:ext cx="6845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BXA2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32" name="直接连接符 231"/>
          <p:cNvCxnSpPr>
            <a:stCxn id="230" idx="2"/>
          </p:cNvCxnSpPr>
          <p:nvPr/>
        </p:nvCxnSpPr>
        <p:spPr>
          <a:xfrm>
            <a:off x="1799773" y="1042708"/>
            <a:ext cx="275899" cy="12386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文本框 232"/>
          <p:cNvSpPr txBox="1"/>
          <p:nvPr/>
        </p:nvSpPr>
        <p:spPr>
          <a:xfrm>
            <a:off x="1809400" y="598994"/>
            <a:ext cx="6451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TGER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35" name="直接连接符 234"/>
          <p:cNvCxnSpPr>
            <a:stCxn id="233" idx="2"/>
          </p:cNvCxnSpPr>
          <p:nvPr/>
        </p:nvCxnSpPr>
        <p:spPr>
          <a:xfrm>
            <a:off x="2131954" y="829827"/>
            <a:ext cx="314332" cy="14663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文本框 235"/>
          <p:cNvSpPr txBox="1"/>
          <p:nvPr/>
        </p:nvSpPr>
        <p:spPr>
          <a:xfrm>
            <a:off x="2035731" y="283998"/>
            <a:ext cx="6451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TGER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38" name="直接连接符 237"/>
          <p:cNvCxnSpPr>
            <a:stCxn id="236" idx="2"/>
          </p:cNvCxnSpPr>
          <p:nvPr/>
        </p:nvCxnSpPr>
        <p:spPr>
          <a:xfrm>
            <a:off x="2358285" y="514831"/>
            <a:ext cx="316008" cy="24875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文本框 232"/>
          <p:cNvSpPr txBox="1"/>
          <p:nvPr/>
        </p:nvSpPr>
        <p:spPr>
          <a:xfrm>
            <a:off x="3201164" y="25279"/>
            <a:ext cx="6451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TGER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41" name="直接连接符 240"/>
          <p:cNvCxnSpPr/>
          <p:nvPr/>
        </p:nvCxnSpPr>
        <p:spPr>
          <a:xfrm>
            <a:off x="3353895" y="186557"/>
            <a:ext cx="115794" cy="2542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2" name="文本框 241"/>
          <p:cNvSpPr txBox="1"/>
          <p:nvPr/>
        </p:nvSpPr>
        <p:spPr>
          <a:xfrm>
            <a:off x="2512333" y="197315"/>
            <a:ext cx="6084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TGD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44" name="直接连接符 243"/>
          <p:cNvCxnSpPr/>
          <p:nvPr/>
        </p:nvCxnSpPr>
        <p:spPr>
          <a:xfrm>
            <a:off x="2807611" y="406499"/>
            <a:ext cx="143751" cy="14294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5" name="文本框 244"/>
          <p:cNvSpPr txBox="1"/>
          <p:nvPr/>
        </p:nvSpPr>
        <p:spPr>
          <a:xfrm>
            <a:off x="2778014" y="66951"/>
            <a:ext cx="5914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TGI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47" name="直接连接符 246"/>
          <p:cNvCxnSpPr>
            <a:stCxn id="245" idx="2"/>
          </p:cNvCxnSpPr>
          <p:nvPr/>
        </p:nvCxnSpPr>
        <p:spPr>
          <a:xfrm>
            <a:off x="3073724" y="297783"/>
            <a:ext cx="163314" cy="1880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文本框 251"/>
          <p:cNvSpPr txBox="1"/>
          <p:nvPr/>
        </p:nvSpPr>
        <p:spPr>
          <a:xfrm>
            <a:off x="428605" y="5564203"/>
            <a:ext cx="1675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Rhodopsin (</a:t>
            </a:r>
            <a:r>
              <a:rPr lang="el-GR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α</a:t>
            </a:r>
            <a:r>
              <a:rPr lang="en-US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)</a:t>
            </a:r>
            <a:endParaRPr lang="zh-CN" altLang="en-US" sz="1400" b="1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6" name="文本框 135"/>
          <p:cNvSpPr txBox="1"/>
          <p:nvPr/>
        </p:nvSpPr>
        <p:spPr>
          <a:xfrm>
            <a:off x="425898" y="164662"/>
            <a:ext cx="495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0300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5474" y="231281"/>
            <a:ext cx="5496791" cy="5855436"/>
          </a:xfrm>
        </p:spPr>
      </p:pic>
      <p:sp>
        <p:nvSpPr>
          <p:cNvPr id="5" name="文本框 4"/>
          <p:cNvSpPr txBox="1"/>
          <p:nvPr/>
        </p:nvSpPr>
        <p:spPr>
          <a:xfrm>
            <a:off x="6530903" y="822938"/>
            <a:ext cx="6251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NRH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7083353" y="1625009"/>
            <a:ext cx="6650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VPR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7293767" y="2572252"/>
            <a:ext cx="5593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OXT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7203348" y="3399827"/>
            <a:ext cx="6528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VPR1B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7073018" y="4089375"/>
            <a:ext cx="6528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VPR1A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060030" y="5078773"/>
            <a:ext cx="571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RP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405910" y="5664851"/>
            <a:ext cx="5507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NMB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689464" y="5830794"/>
            <a:ext cx="571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BRS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623933" y="6049001"/>
            <a:ext cx="5888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37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698900" y="5780267"/>
            <a:ext cx="613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EDNRA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875442" y="5218374"/>
            <a:ext cx="613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EDNRB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325924" y="4291873"/>
            <a:ext cx="571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NPY1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7" name="文本框 7"/>
          <p:cNvSpPr txBox="1"/>
          <p:nvPr/>
        </p:nvSpPr>
        <p:spPr>
          <a:xfrm>
            <a:off x="810376" y="2842268"/>
            <a:ext cx="6528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VPR2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8" name="文本框 7"/>
          <p:cNvSpPr txBox="1"/>
          <p:nvPr/>
        </p:nvSpPr>
        <p:spPr>
          <a:xfrm>
            <a:off x="758752" y="3547016"/>
            <a:ext cx="6528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VPR5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961312" y="1886634"/>
            <a:ext cx="6754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CKA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556867" y="1046128"/>
            <a:ext cx="6754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CKB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322679" y="301053"/>
            <a:ext cx="6173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ACR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049732" y="31014"/>
            <a:ext cx="6173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ACR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156633" y="38165"/>
            <a:ext cx="6173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AC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405909" y="416469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HCRT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425898" y="5412410"/>
            <a:ext cx="1675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Rhodopsin (</a:t>
            </a:r>
            <a:r>
              <a:rPr lang="el-GR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β</a:t>
            </a:r>
            <a:r>
              <a:rPr lang="en-US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)</a:t>
            </a:r>
            <a:endParaRPr lang="zh-CN" altLang="en-US" sz="1400" b="1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" name="弧形 1"/>
          <p:cNvSpPr/>
          <p:nvPr/>
        </p:nvSpPr>
        <p:spPr>
          <a:xfrm rot="18603089">
            <a:off x="2085365" y="356186"/>
            <a:ext cx="3046736" cy="2537646"/>
          </a:xfrm>
          <a:prstGeom prst="arc">
            <a:avLst>
              <a:gd name="adj1" fmla="val 16200000"/>
              <a:gd name="adj2" fmla="val 155936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弧形 2"/>
          <p:cNvSpPr/>
          <p:nvPr/>
        </p:nvSpPr>
        <p:spPr>
          <a:xfrm>
            <a:off x="4857540" y="721315"/>
            <a:ext cx="806849" cy="664911"/>
          </a:xfrm>
          <a:prstGeom prst="arc">
            <a:avLst>
              <a:gd name="adj1" fmla="val 14818310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弧形 45"/>
          <p:cNvSpPr/>
          <p:nvPr/>
        </p:nvSpPr>
        <p:spPr>
          <a:xfrm rot="1727798">
            <a:off x="3636834" y="849382"/>
            <a:ext cx="3571398" cy="4050337"/>
          </a:xfrm>
          <a:prstGeom prst="arc">
            <a:avLst>
              <a:gd name="adj1" fmla="val 16089932"/>
              <a:gd name="adj2" fmla="val 1171308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弧形 46"/>
          <p:cNvSpPr/>
          <p:nvPr/>
        </p:nvSpPr>
        <p:spPr>
          <a:xfrm rot="14279672">
            <a:off x="999806" y="1761923"/>
            <a:ext cx="4459964" cy="3082556"/>
          </a:xfrm>
          <a:prstGeom prst="arc">
            <a:avLst>
              <a:gd name="adj1" fmla="val 15790448"/>
              <a:gd name="adj2" fmla="val 655276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弧形 47"/>
          <p:cNvSpPr/>
          <p:nvPr/>
        </p:nvSpPr>
        <p:spPr>
          <a:xfrm rot="8541232">
            <a:off x="2031482" y="1904381"/>
            <a:ext cx="4698736" cy="3912034"/>
          </a:xfrm>
          <a:prstGeom prst="arc">
            <a:avLst>
              <a:gd name="adj1" fmla="val 14500256"/>
              <a:gd name="adj2" fmla="val 89595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425898" y="164662"/>
            <a:ext cx="495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57418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043" y="303139"/>
            <a:ext cx="5493108" cy="5943980"/>
          </a:xfrm>
        </p:spPr>
      </p:pic>
      <p:sp>
        <p:nvSpPr>
          <p:cNvPr id="5" name="文本框 4"/>
          <p:cNvSpPr txBox="1"/>
          <p:nvPr/>
        </p:nvSpPr>
        <p:spPr>
          <a:xfrm>
            <a:off x="6220538" y="954002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15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6547817" y="1371072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25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814297" y="1973307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XCR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7046440" y="2618475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XCR5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7020180" y="3195154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XCR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943748" y="3665084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XCR2 (CXCR1)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666852" y="4365847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CR9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407727" y="4878882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XCR6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070238" y="5316510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CR7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463237" y="5585697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CR6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735077" y="5874312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XC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312130" y="6060245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CRL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997033" y="5957818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CR8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659221" y="5794632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CR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310855" y="5685378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CR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0" name="文本框 17"/>
          <p:cNvSpPr txBox="1"/>
          <p:nvPr/>
        </p:nvSpPr>
        <p:spPr>
          <a:xfrm>
            <a:off x="2615572" y="5499758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STR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1" name="文本框 17"/>
          <p:cNvSpPr txBox="1"/>
          <p:nvPr/>
        </p:nvSpPr>
        <p:spPr>
          <a:xfrm>
            <a:off x="2069355" y="5157323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STR5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2" name="文本框 17"/>
          <p:cNvSpPr txBox="1"/>
          <p:nvPr/>
        </p:nvSpPr>
        <p:spPr>
          <a:xfrm>
            <a:off x="1597819" y="4723938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STR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3" name="文本框 17"/>
          <p:cNvSpPr txBox="1"/>
          <p:nvPr/>
        </p:nvSpPr>
        <p:spPr>
          <a:xfrm>
            <a:off x="1196021" y="4145328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STR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4" name="文本框 17"/>
          <p:cNvSpPr txBox="1"/>
          <p:nvPr/>
        </p:nvSpPr>
        <p:spPr>
          <a:xfrm>
            <a:off x="1008156" y="3764508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ST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5" name="文本框 17"/>
          <p:cNvSpPr txBox="1"/>
          <p:nvPr/>
        </p:nvSpPr>
        <p:spPr>
          <a:xfrm>
            <a:off x="757025" y="3141885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OPRL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6" name="文本框 17"/>
          <p:cNvSpPr txBox="1"/>
          <p:nvPr/>
        </p:nvSpPr>
        <p:spPr>
          <a:xfrm>
            <a:off x="646403" y="2414493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OPRK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7" name="文本框 17"/>
          <p:cNvSpPr txBox="1"/>
          <p:nvPr/>
        </p:nvSpPr>
        <p:spPr>
          <a:xfrm>
            <a:off x="837757" y="1838664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OPRD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8" name="文本框 17"/>
          <p:cNvSpPr txBox="1"/>
          <p:nvPr/>
        </p:nvSpPr>
        <p:spPr>
          <a:xfrm>
            <a:off x="982352" y="1453034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OPRM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9" name="文本框 17"/>
          <p:cNvSpPr txBox="1"/>
          <p:nvPr/>
        </p:nvSpPr>
        <p:spPr>
          <a:xfrm>
            <a:off x="1422042" y="772684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MCHR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0" name="文本框 17"/>
          <p:cNvSpPr txBox="1"/>
          <p:nvPr/>
        </p:nvSpPr>
        <p:spPr>
          <a:xfrm>
            <a:off x="1951644" y="403068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MCH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1" name="文本框 17"/>
          <p:cNvSpPr txBox="1"/>
          <p:nvPr/>
        </p:nvSpPr>
        <p:spPr>
          <a:xfrm>
            <a:off x="2468220" y="248360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P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2" name="文本框 17"/>
          <p:cNvSpPr txBox="1"/>
          <p:nvPr/>
        </p:nvSpPr>
        <p:spPr>
          <a:xfrm>
            <a:off x="2743735" y="62982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3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3" name="文本框 17"/>
          <p:cNvSpPr txBox="1"/>
          <p:nvPr/>
        </p:nvSpPr>
        <p:spPr>
          <a:xfrm>
            <a:off x="3178448" y="113639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MKL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4" name="文本框 17"/>
          <p:cNvSpPr txBox="1"/>
          <p:nvPr/>
        </p:nvSpPr>
        <p:spPr>
          <a:xfrm>
            <a:off x="3743813" y="54917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BDKRB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5" name="文本框 17"/>
          <p:cNvSpPr txBox="1"/>
          <p:nvPr/>
        </p:nvSpPr>
        <p:spPr>
          <a:xfrm>
            <a:off x="4342694" y="218103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BDKRB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6" name="文本框 17"/>
          <p:cNvSpPr txBox="1"/>
          <p:nvPr/>
        </p:nvSpPr>
        <p:spPr>
          <a:xfrm>
            <a:off x="5049998" y="369747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GTR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8" name="文本框 17"/>
          <p:cNvSpPr txBox="1"/>
          <p:nvPr/>
        </p:nvSpPr>
        <p:spPr>
          <a:xfrm>
            <a:off x="5627182" y="671799"/>
            <a:ext cx="1186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GT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56" name="弧形 55"/>
          <p:cNvSpPr/>
          <p:nvPr/>
        </p:nvSpPr>
        <p:spPr>
          <a:xfrm rot="17708320">
            <a:off x="2070262" y="-542"/>
            <a:ext cx="3690700" cy="4447453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弧形 56"/>
          <p:cNvSpPr/>
          <p:nvPr/>
        </p:nvSpPr>
        <p:spPr>
          <a:xfrm>
            <a:off x="4221216" y="635571"/>
            <a:ext cx="1585173" cy="1167852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弧形 57"/>
          <p:cNvSpPr/>
          <p:nvPr/>
        </p:nvSpPr>
        <p:spPr>
          <a:xfrm>
            <a:off x="5889813" y="1232450"/>
            <a:ext cx="667389" cy="749813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弧形 58"/>
          <p:cNvSpPr/>
          <p:nvPr/>
        </p:nvSpPr>
        <p:spPr>
          <a:xfrm rot="3491631">
            <a:off x="1975428" y="719044"/>
            <a:ext cx="4543228" cy="5811074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弧形 1"/>
          <p:cNvSpPr/>
          <p:nvPr/>
        </p:nvSpPr>
        <p:spPr>
          <a:xfrm rot="12558063">
            <a:off x="1268525" y="763881"/>
            <a:ext cx="5860232" cy="4890637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弧形 2"/>
          <p:cNvSpPr/>
          <p:nvPr/>
        </p:nvSpPr>
        <p:spPr>
          <a:xfrm rot="7562775">
            <a:off x="3190908" y="3500617"/>
            <a:ext cx="1608874" cy="2724743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441143" y="5240496"/>
            <a:ext cx="1608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Rhodopsin (</a:t>
            </a:r>
            <a:r>
              <a:rPr lang="el-GR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γ</a:t>
            </a:r>
            <a:r>
              <a:rPr lang="en-US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)</a:t>
            </a:r>
            <a:endParaRPr lang="zh-CN" altLang="en-US" sz="1400" b="1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425898" y="179302"/>
            <a:ext cx="475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20764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5873" y="236942"/>
            <a:ext cx="5361697" cy="5826904"/>
          </a:xfrm>
        </p:spPr>
      </p:pic>
      <p:sp>
        <p:nvSpPr>
          <p:cNvPr id="5" name="弧形 4"/>
          <p:cNvSpPr/>
          <p:nvPr/>
        </p:nvSpPr>
        <p:spPr>
          <a:xfrm rot="2490112">
            <a:off x="2421555" y="473770"/>
            <a:ext cx="4858999" cy="4927222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弧形 5"/>
          <p:cNvSpPr/>
          <p:nvPr/>
        </p:nvSpPr>
        <p:spPr>
          <a:xfrm rot="19126024">
            <a:off x="2237771" y="147978"/>
            <a:ext cx="4327725" cy="4331898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弧形 6"/>
          <p:cNvSpPr/>
          <p:nvPr/>
        </p:nvSpPr>
        <p:spPr>
          <a:xfrm rot="16200000">
            <a:off x="2364010" y="1077252"/>
            <a:ext cx="845922" cy="892600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弧形 7"/>
          <p:cNvSpPr/>
          <p:nvPr/>
        </p:nvSpPr>
        <p:spPr>
          <a:xfrm rot="13675665">
            <a:off x="1553520" y="1618683"/>
            <a:ext cx="3871011" cy="3186744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弧形 8"/>
          <p:cNvSpPr/>
          <p:nvPr/>
        </p:nvSpPr>
        <p:spPr>
          <a:xfrm rot="8341421">
            <a:off x="1863599" y="612566"/>
            <a:ext cx="5827928" cy="5374254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936515" y="145189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2RL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898245" y="-39766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2RL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830798" y="14302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2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729025" y="272741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2RL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765007" y="1079809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65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7140846" y="1591463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393673" y="2198511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68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339213" y="3184277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18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126038" y="4142301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35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6471229" y="5470384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LGR5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5931937" y="5821903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LGR6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274317" y="6055553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LGR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738789" y="6051021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SH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065812" y="5920537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LHCG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4" name="文本框 21"/>
          <p:cNvSpPr txBox="1"/>
          <p:nvPr/>
        </p:nvSpPr>
        <p:spPr>
          <a:xfrm>
            <a:off x="2161500" y="5422928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SH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5" name="文本框 21"/>
          <p:cNvSpPr txBox="1"/>
          <p:nvPr/>
        </p:nvSpPr>
        <p:spPr>
          <a:xfrm>
            <a:off x="1616882" y="4163083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2RY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6" name="文本框 21"/>
          <p:cNvSpPr txBox="1"/>
          <p:nvPr/>
        </p:nvSpPr>
        <p:spPr>
          <a:xfrm>
            <a:off x="1206328" y="3483285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2RY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7" name="文本框 21"/>
          <p:cNvSpPr txBox="1"/>
          <p:nvPr/>
        </p:nvSpPr>
        <p:spPr>
          <a:xfrm>
            <a:off x="1016767" y="2636397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2RY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8" name="文本框 21"/>
          <p:cNvSpPr txBox="1"/>
          <p:nvPr/>
        </p:nvSpPr>
        <p:spPr>
          <a:xfrm>
            <a:off x="1279522" y="1845071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2RY6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9" name="文本框 21"/>
          <p:cNvSpPr txBox="1"/>
          <p:nvPr/>
        </p:nvSpPr>
        <p:spPr>
          <a:xfrm>
            <a:off x="1838148" y="950555"/>
            <a:ext cx="909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17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425898" y="5342174"/>
            <a:ext cx="1675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Rhodopsin (</a:t>
            </a:r>
            <a:r>
              <a:rPr lang="el-GR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δ</a:t>
            </a:r>
            <a:r>
              <a:rPr lang="en-US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)</a:t>
            </a:r>
            <a:endParaRPr lang="zh-CN" altLang="en-US" sz="1400" b="1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425898" y="164662"/>
            <a:ext cx="495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20761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9816" y="267110"/>
            <a:ext cx="4928107" cy="5766569"/>
          </a:xfrm>
        </p:spPr>
      </p:pic>
      <p:sp>
        <p:nvSpPr>
          <p:cNvPr id="5" name="弧形 4"/>
          <p:cNvSpPr/>
          <p:nvPr/>
        </p:nvSpPr>
        <p:spPr>
          <a:xfrm rot="6463159" flipH="1">
            <a:off x="1850850" y="526273"/>
            <a:ext cx="5111955" cy="4894948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弧形 5"/>
          <p:cNvSpPr/>
          <p:nvPr/>
        </p:nvSpPr>
        <p:spPr>
          <a:xfrm rot="936665" flipH="1">
            <a:off x="1817126" y="255137"/>
            <a:ext cx="4846158" cy="5303613"/>
          </a:xfrm>
          <a:prstGeom prst="arc">
            <a:avLst>
              <a:gd name="adj1" fmla="val 16200000"/>
              <a:gd name="adj2" fmla="val 72400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弧形 6"/>
          <p:cNvSpPr/>
          <p:nvPr/>
        </p:nvSpPr>
        <p:spPr>
          <a:xfrm rot="10177934">
            <a:off x="1802456" y="1776662"/>
            <a:ext cx="4148871" cy="4171017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弧形 7"/>
          <p:cNvSpPr/>
          <p:nvPr/>
        </p:nvSpPr>
        <p:spPr>
          <a:xfrm rot="7247848">
            <a:off x="4224143" y="4226216"/>
            <a:ext cx="1456416" cy="1672210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弧形 10"/>
          <p:cNvSpPr/>
          <p:nvPr/>
        </p:nvSpPr>
        <p:spPr>
          <a:xfrm rot="5090284">
            <a:off x="5461504" y="3825803"/>
            <a:ext cx="945572" cy="1049482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814797" y="650341"/>
            <a:ext cx="602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RM7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318475" y="1148989"/>
            <a:ext cx="602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RM6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715436" y="1852802"/>
            <a:ext cx="602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RM8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6903737" y="2325783"/>
            <a:ext cx="602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RM4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6" name="文本框 11"/>
          <p:cNvSpPr txBox="1"/>
          <p:nvPr/>
        </p:nvSpPr>
        <p:spPr>
          <a:xfrm>
            <a:off x="3051518" y="133519"/>
            <a:ext cx="602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RM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7" name="文本框 11"/>
          <p:cNvSpPr txBox="1"/>
          <p:nvPr/>
        </p:nvSpPr>
        <p:spPr>
          <a:xfrm>
            <a:off x="3983326" y="6663"/>
            <a:ext cx="602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RM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8" name="文本框 11"/>
          <p:cNvSpPr txBox="1"/>
          <p:nvPr/>
        </p:nvSpPr>
        <p:spPr>
          <a:xfrm>
            <a:off x="1580780" y="1321967"/>
            <a:ext cx="602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RM5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9" name="文本框 11"/>
          <p:cNvSpPr txBox="1"/>
          <p:nvPr/>
        </p:nvSpPr>
        <p:spPr>
          <a:xfrm>
            <a:off x="1139236" y="2361359"/>
            <a:ext cx="602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RM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0" name="文本框 11"/>
          <p:cNvSpPr txBox="1"/>
          <p:nvPr/>
        </p:nvSpPr>
        <p:spPr>
          <a:xfrm>
            <a:off x="1362665" y="4877456"/>
            <a:ext cx="6470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AS1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1" name="文本框 11"/>
          <p:cNvSpPr txBox="1"/>
          <p:nvPr/>
        </p:nvSpPr>
        <p:spPr>
          <a:xfrm>
            <a:off x="2156792" y="5590965"/>
            <a:ext cx="6837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AS1R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2" name="文本框 11"/>
          <p:cNvSpPr txBox="1"/>
          <p:nvPr/>
        </p:nvSpPr>
        <p:spPr>
          <a:xfrm>
            <a:off x="3350743" y="6070208"/>
            <a:ext cx="6317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AS1R3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3" name="文本框 11"/>
          <p:cNvSpPr txBox="1"/>
          <p:nvPr/>
        </p:nvSpPr>
        <p:spPr>
          <a:xfrm>
            <a:off x="4879615" y="5914712"/>
            <a:ext cx="7263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PRC6A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4" name="文本框 11"/>
          <p:cNvSpPr txBox="1"/>
          <p:nvPr/>
        </p:nvSpPr>
        <p:spPr>
          <a:xfrm>
            <a:off x="6269491" y="4804093"/>
            <a:ext cx="602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AS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71464" y="5472486"/>
            <a:ext cx="1675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lutamate</a:t>
            </a:r>
            <a:endParaRPr lang="zh-CN" altLang="en-US" sz="1400" b="1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25898" y="164662"/>
            <a:ext cx="495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55220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2723" y="968303"/>
            <a:ext cx="6082293" cy="4904509"/>
          </a:xfrm>
        </p:spPr>
      </p:pic>
      <p:sp>
        <p:nvSpPr>
          <p:cNvPr id="5" name="文本框 4"/>
          <p:cNvSpPr txBox="1"/>
          <p:nvPr/>
        </p:nvSpPr>
        <p:spPr>
          <a:xfrm>
            <a:off x="7285387" y="1207295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>
                <a:latin typeface="微软雅黑" panose="020B0503020204020204" pitchFamily="34" charset="-122"/>
                <a:ea typeface="微软雅黑" panose="020B0503020204020204" pitchFamily="34" charset="-122"/>
              </a:rPr>
              <a:t>GABBR2</a:t>
            </a:r>
            <a:endParaRPr lang="zh-CN" altLang="en-US" sz="900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806305" y="3645694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ABB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9" name="弧形 8"/>
          <p:cNvSpPr/>
          <p:nvPr/>
        </p:nvSpPr>
        <p:spPr>
          <a:xfrm rot="15957434">
            <a:off x="946046" y="2150296"/>
            <a:ext cx="2284915" cy="1544768"/>
          </a:xfrm>
          <a:prstGeom prst="arc">
            <a:avLst>
              <a:gd name="adj1" fmla="val 1263490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弧形 9"/>
          <p:cNvSpPr/>
          <p:nvPr/>
        </p:nvSpPr>
        <p:spPr>
          <a:xfrm rot="2115194">
            <a:off x="4850905" y="776288"/>
            <a:ext cx="2432344" cy="3019258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432103" y="4877057"/>
            <a:ext cx="222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lutamate_GABBR</a:t>
            </a:r>
            <a:endParaRPr lang="zh-CN" altLang="en-US" sz="1400" b="1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25898" y="164662"/>
            <a:ext cx="495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88490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内容占位符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9184" y="297621"/>
            <a:ext cx="4910957" cy="6003167"/>
          </a:xfrm>
        </p:spPr>
      </p:pic>
      <p:sp>
        <p:nvSpPr>
          <p:cNvPr id="8" name="弧形 7"/>
          <p:cNvSpPr/>
          <p:nvPr/>
        </p:nvSpPr>
        <p:spPr>
          <a:xfrm rot="18269022">
            <a:off x="1767209" y="594683"/>
            <a:ext cx="5147718" cy="4151448"/>
          </a:xfrm>
          <a:prstGeom prst="arc">
            <a:avLst>
              <a:gd name="adj1" fmla="val 18260975"/>
              <a:gd name="adj2" fmla="val 2032519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弧形 8"/>
          <p:cNvSpPr/>
          <p:nvPr/>
        </p:nvSpPr>
        <p:spPr>
          <a:xfrm rot="15946532">
            <a:off x="1295760" y="1447888"/>
            <a:ext cx="3721243" cy="2991819"/>
          </a:xfrm>
          <a:prstGeom prst="arc">
            <a:avLst>
              <a:gd name="adj1" fmla="val 13043949"/>
              <a:gd name="adj2" fmla="val 49381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弧形 9"/>
          <p:cNvSpPr/>
          <p:nvPr/>
        </p:nvSpPr>
        <p:spPr>
          <a:xfrm rot="2882740">
            <a:off x="4738229" y="2198836"/>
            <a:ext cx="1978432" cy="2547155"/>
          </a:xfrm>
          <a:prstGeom prst="arc">
            <a:avLst>
              <a:gd name="adj1" fmla="val 15335172"/>
              <a:gd name="adj2" fmla="val 21328808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弧形 10"/>
          <p:cNvSpPr/>
          <p:nvPr/>
        </p:nvSpPr>
        <p:spPr>
          <a:xfrm rot="10035383">
            <a:off x="2373831" y="3438843"/>
            <a:ext cx="2841577" cy="2368489"/>
          </a:xfrm>
          <a:prstGeom prst="arc">
            <a:avLst>
              <a:gd name="adj1" fmla="val 16408518"/>
              <a:gd name="adj2" fmla="val 17779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478622" y="112561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LP-2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631519" y="49246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LP-1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744354" y="297620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IP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" name="文本框 12"/>
          <p:cNvSpPr txBox="1"/>
          <p:nvPr/>
        </p:nvSpPr>
        <p:spPr>
          <a:xfrm>
            <a:off x="6576554" y="1091469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CG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6" name="文本框 12"/>
          <p:cNvSpPr txBox="1"/>
          <p:nvPr/>
        </p:nvSpPr>
        <p:spPr>
          <a:xfrm>
            <a:off x="6975039" y="2563752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TH1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7" name="文本框 12"/>
          <p:cNvSpPr txBox="1"/>
          <p:nvPr/>
        </p:nvSpPr>
        <p:spPr>
          <a:xfrm>
            <a:off x="6810951" y="3696213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PTH2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9" name="文本框 12"/>
          <p:cNvSpPr txBox="1"/>
          <p:nvPr/>
        </p:nvSpPr>
        <p:spPr>
          <a:xfrm>
            <a:off x="5877694" y="5244565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RH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0" name="文本框 12"/>
          <p:cNvSpPr txBox="1"/>
          <p:nvPr/>
        </p:nvSpPr>
        <p:spPr>
          <a:xfrm>
            <a:off x="4963778" y="5622524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RHR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1" name="文本框 12"/>
          <p:cNvSpPr txBox="1"/>
          <p:nvPr/>
        </p:nvSpPr>
        <p:spPr>
          <a:xfrm>
            <a:off x="2481839" y="5695949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ALC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2" name="文本框 12"/>
          <p:cNvSpPr txBox="1"/>
          <p:nvPr/>
        </p:nvSpPr>
        <p:spPr>
          <a:xfrm>
            <a:off x="1008739" y="3696213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VIPR1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3" name="文本框 12"/>
          <p:cNvSpPr txBox="1"/>
          <p:nvPr/>
        </p:nvSpPr>
        <p:spPr>
          <a:xfrm>
            <a:off x="981218" y="2502511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VIPR2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4" name="文本框 12"/>
          <p:cNvSpPr txBox="1"/>
          <p:nvPr/>
        </p:nvSpPr>
        <p:spPr>
          <a:xfrm>
            <a:off x="1527474" y="1256062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HRH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5" name="文本框 12"/>
          <p:cNvSpPr txBox="1"/>
          <p:nvPr/>
        </p:nvSpPr>
        <p:spPr>
          <a:xfrm>
            <a:off x="2616176" y="811253"/>
            <a:ext cx="8624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CTR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756346" y="5289406"/>
            <a:ext cx="1675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ecretin</a:t>
            </a:r>
            <a:endParaRPr lang="zh-CN" altLang="en-US" sz="1400" b="1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25898" y="164662"/>
            <a:ext cx="495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9826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C7EDCC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9</TotalTime>
  <Words>195</Words>
  <Application>Microsoft Office PowerPoint</Application>
  <PresentationFormat>自定义</PresentationFormat>
  <Paragraphs>180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3" baseType="lpstr">
      <vt:lpstr>宋体</vt:lpstr>
      <vt:lpstr>微软雅黑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rley Sa</dc:creator>
  <cp:lastModifiedBy>萨芝宁</cp:lastModifiedBy>
  <cp:revision>44</cp:revision>
  <dcterms:created xsi:type="dcterms:W3CDTF">2016-12-29T07:56:26Z</dcterms:created>
  <dcterms:modified xsi:type="dcterms:W3CDTF">2017-05-28T09:26:04Z</dcterms:modified>
</cp:coreProperties>
</file>